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71" r:id="rId2"/>
    <p:sldId id="265" r:id="rId3"/>
    <p:sldId id="268" r:id="rId4"/>
    <p:sldId id="272" r:id="rId5"/>
    <p:sldId id="273" r:id="rId6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4212A96-F812-96E5-4534-EF45BA663588}" name="Paul Ackermann" initials="PA" userId="S::paul.ackermann@ki.se::ae8344e7-f413-473b-a7d4-cf3a88ffc32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63" autoAdjust="0"/>
    <p:restoredTop sz="89329" autoAdjust="0"/>
  </p:normalViewPr>
  <p:slideViewPr>
    <p:cSldViewPr snapToGrid="0">
      <p:cViewPr varScale="1">
        <p:scale>
          <a:sx n="100" d="100"/>
          <a:sy n="100" d="100"/>
        </p:scale>
        <p:origin x="100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8/10/relationships/authors" Target="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E75A76-D19D-F167-339F-755752E99C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3687F4-EC11-E362-9209-0E1C7C696F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C20283-6332-4701-AE82-0406DC8038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76D553-A9B2-73DD-204D-F49748891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756EE5-5CF8-22DA-6802-F4829FF5F4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30480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B5402B-B0F2-9B21-2F40-B8C4B2C072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3F2EA3-83D9-1FEC-81BB-F44B7C080F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FD3EA0-71D8-0A9E-E11E-EBCD1F4909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D95A4E-D203-7E57-B348-A68B38B694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4AFF55-F9A8-2073-7622-4F34A11BA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92449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2F70332-F9DB-3E99-6D7E-DC41E66AC5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022A7D-681F-4C65-A659-AA4184AF19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82B242-853E-CE30-E774-399E4F6DE4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7CD00A-2DAC-4D54-2566-E02A7E2A5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08743E-6BAE-B1CD-6AB2-D022EF8E60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30028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627E5E-F411-FA62-5949-816C9A6A4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C5DBBE-8991-FEE8-FCD0-7A466A0C87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1A9997-D723-C51F-A395-0363E3AEC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B1E419-ED74-A77F-7115-59593C65C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C6D86A-DED7-D71D-2F92-82A69D261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86402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93D5EB-4D74-3078-37DC-C4ECC2BAEC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9CE6C9-F047-4C98-FFE9-FB8FE01F10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CF2BD5-3274-1964-2CC5-5F8BDEDB9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9272A6-1CE0-3B12-57B8-352B39BA1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7927F5-C217-E432-7881-B662A47176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89570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3B17A-75FF-EB2F-980C-4AF4084EF6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9BA86E-1484-FE17-3DE4-B41202BF49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53FF7B-DFA1-42DA-2E29-9B762619DD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20689C-3EA0-A681-46A7-194F781E8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DEC080-3FFB-92AE-4A6C-D9F39EE2D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B527A8-B45E-0080-9873-18D6398F0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75518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FFF77D-5F73-C96A-CBC3-32991F5D8A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7C1A93-D221-D71E-B154-77A9AC3CE0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69C50D-0795-AFCC-D630-1C562661E9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4C53D5-568B-4476-682C-7D8F518F16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BF4756-AF21-C5E4-8452-56CFDC5F01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57CF6AE-4903-5C4B-FBE6-46B88EB01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C0422AF-F9B3-71CC-A8F5-2489DEA47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0DB7DC-FB55-544A-0629-C1264C8E47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92213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AE32C3-F5BF-9A2C-2F9E-D28C09401F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037482-B61A-E96C-4C19-569DC3B4D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D9898B5-3805-4874-4A87-51231710A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57AED1-E444-32EA-0270-F1162134E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58097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DC2F8BC-BD56-C7DB-DF9E-E7DE243DDE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91CE5A-F306-BEF3-BD46-F9C1B4E07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EFDA5E-4B46-113D-156F-38D7094041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68182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02CEDF-A4AC-DA0A-906C-C730F9710F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B78F11-D580-5830-9282-368F5EA9B6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242F84-B0BE-6B37-C201-AC11445E28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4C220C-467A-C3AE-E224-9D8F287A6E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6238E8-5FA4-DFE5-5CD4-A51C98821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CB82D2-1D13-F86A-A663-A4E6337EB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69327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15DC43-15E1-1580-FE09-B9EC3F667E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15863E1-FFFE-28D1-D737-30283E811E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36207B-1F3F-B3C4-FF96-E44C36D7BD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44F130-C237-3EF2-4446-E67BDD0B6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2B37A2-6976-3C3A-C080-2F0518D01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3C1662-3290-E861-5977-691B286FC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79805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71F2E4F-F6CA-D630-4244-DED660A7AD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BC4A28-1D43-8C08-D1E1-2CE410FB5F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187E2D-3B47-A9AE-F8A6-541FCB65D9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9A1A0C-BD66-4AA9-A1B5-1CEB0907D62C}" type="datetimeFigureOut">
              <a:rPr lang="sv-SE" smtClean="0"/>
              <a:t>2026-02-2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58B5FD-6E32-B9F6-2206-DE4C1CD2B4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CA7B8A-D190-78F3-DF56-8B922B9C43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E3B5557-FEDD-4F56-9DF3-7FAB21A704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42737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0153D82-B857-C281-549C-FC57E2435A3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Content Placeholder 18" descr="A diagram of a normal distribution&#10;&#10;AI-generated content may be incorrect.">
            <a:extLst>
              <a:ext uri="{FF2B5EF4-FFF2-40B4-BE49-F238E27FC236}">
                <a16:creationId xmlns:a16="http://schemas.microsoft.com/office/drawing/2014/main" id="{176EEE32-F081-FCD6-6F48-AA962700854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2205" y="2343030"/>
            <a:ext cx="6347365" cy="4351338"/>
          </a:xfrm>
        </p:spPr>
      </p:pic>
      <p:pic>
        <p:nvPicPr>
          <p:cNvPr id="11" name="Picture 10" descr="A graph of a normal distribution&#10;&#10;AI-generated content may be incorrect.">
            <a:extLst>
              <a:ext uri="{FF2B5EF4-FFF2-40B4-BE49-F238E27FC236}">
                <a16:creationId xmlns:a16="http://schemas.microsoft.com/office/drawing/2014/main" id="{1058E3FB-74C1-D352-3A50-68040D3A65C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14600"/>
            <a:ext cx="6027622" cy="413214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9B2AAD8-A105-ABD5-9D73-A392E01D7DDA}"/>
              </a:ext>
            </a:extLst>
          </p:cNvPr>
          <p:cNvSpPr txBox="1"/>
          <p:nvPr/>
        </p:nvSpPr>
        <p:spPr>
          <a:xfrm>
            <a:off x="3429000" y="763588"/>
            <a:ext cx="60960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i="0" u="none" strike="noStrike" dirty="0">
                <a:effectLst/>
              </a:rPr>
              <a:t>Supplementary Fig. 1A-B. </a:t>
            </a:r>
            <a:br>
              <a:rPr lang="en-GB" b="1" i="0" u="none" strike="noStrike" dirty="0">
                <a:effectLst/>
              </a:rPr>
            </a:br>
            <a:r>
              <a:rPr lang="en-GB" b="0" i="0" u="none" strike="noStrike" dirty="0">
                <a:effectLst/>
                <a:latin typeface="-webkit-standard"/>
              </a:rPr>
              <a:t>Impedance distribution at plantar flexion on the left (A) and right (B) legs, comparing effects across all applied interventions.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7641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30E5EFF-C57C-AAA0-D0E7-EBC64A11214B}"/>
              </a:ext>
            </a:extLst>
          </p:cNvPr>
          <p:cNvSpPr txBox="1"/>
          <p:nvPr/>
        </p:nvSpPr>
        <p:spPr>
          <a:xfrm>
            <a:off x="2339897" y="920751"/>
            <a:ext cx="70449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i="0" u="none" strike="noStrike" dirty="0">
                <a:effectLst/>
              </a:rPr>
              <a:t>Supplementary Fig. 2A-C. </a:t>
            </a:r>
            <a:r>
              <a:rPr lang="en-GB" b="0" i="0" u="none" strike="noStrike" dirty="0">
                <a:effectLst/>
                <a:latin typeface="-webkit-standard"/>
              </a:rPr>
              <a:t>Frequency distribution of reported </a:t>
            </a:r>
            <a:r>
              <a:rPr lang="en-GB" b="0" i="0" u="none" strike="noStrike" dirty="0" err="1">
                <a:effectLst/>
                <a:latin typeface="-webkit-standard"/>
              </a:rPr>
              <a:t>PaPF</a:t>
            </a:r>
            <a:r>
              <a:rPr lang="en-GB" b="0" i="0" u="none" strike="noStrike" dirty="0">
                <a:effectLst/>
                <a:latin typeface="-webkit-standard"/>
              </a:rPr>
              <a:t> on the right leg under three conditions: dry electrode (A), after exfoliation (B), and after exfoliation with </a:t>
            </a:r>
            <a:r>
              <a:rPr lang="en-GB" b="0" i="0" u="none" strike="noStrike" dirty="0" err="1">
                <a:effectLst/>
                <a:latin typeface="-webkit-standard"/>
              </a:rPr>
              <a:t>gelpad</a:t>
            </a:r>
            <a:r>
              <a:rPr lang="en-GB" b="0" i="0" u="none" strike="noStrike" dirty="0">
                <a:effectLst/>
                <a:latin typeface="-webkit-standard"/>
              </a:rPr>
              <a:t> application (C), highlighting changes across interventions.</a:t>
            </a:r>
            <a:endParaRPr lang="sv-SE" dirty="0"/>
          </a:p>
        </p:txBody>
      </p:sp>
      <p:pic>
        <p:nvPicPr>
          <p:cNvPr id="9" name="Content Placeholder 4" descr="A graph of a number of pain rating scale&#10;&#10;AI-generated content may be incorrect.">
            <a:extLst>
              <a:ext uri="{FF2B5EF4-FFF2-40B4-BE49-F238E27FC236}">
                <a16:creationId xmlns:a16="http://schemas.microsoft.com/office/drawing/2014/main" id="{9363EE20-C226-703B-8380-D655337D9C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79935"/>
            <a:ext cx="3908238" cy="2679289"/>
          </a:xfrm>
          <a:prstGeom prst="rect">
            <a:avLst/>
          </a:prstGeom>
        </p:spPr>
      </p:pic>
      <p:pic>
        <p:nvPicPr>
          <p:cNvPr id="10" name="Content Placeholder 4" descr="A graph of a number of pain rating scale&#10;&#10;AI-generated content may be incorrect.">
            <a:extLst>
              <a:ext uri="{FF2B5EF4-FFF2-40B4-BE49-F238E27FC236}">
                <a16:creationId xmlns:a16="http://schemas.microsoft.com/office/drawing/2014/main" id="{314A5A67-A007-CBBC-B5FF-508E6B7EE0E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8238" y="2679934"/>
            <a:ext cx="3908238" cy="2679935"/>
          </a:xfrm>
          <a:prstGeom prst="rect">
            <a:avLst/>
          </a:prstGeom>
        </p:spPr>
      </p:pic>
      <p:pic>
        <p:nvPicPr>
          <p:cNvPr id="11" name="Content Placeholder 4" descr="A graph of a number of pain rating scale&#10;&#10;AI-generated content may be incorrect.">
            <a:extLst>
              <a:ext uri="{FF2B5EF4-FFF2-40B4-BE49-F238E27FC236}">
                <a16:creationId xmlns:a16="http://schemas.microsoft.com/office/drawing/2014/main" id="{BACAD73F-85BB-CD08-56CF-B1A82290F86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6476" y="2679933"/>
            <a:ext cx="3908238" cy="26792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7831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4EF1FA5-542F-5409-1237-EF76A69B00D7}"/>
              </a:ext>
            </a:extLst>
          </p:cNvPr>
          <p:cNvSpPr txBox="1"/>
          <p:nvPr/>
        </p:nvSpPr>
        <p:spPr>
          <a:xfrm>
            <a:off x="3018697" y="581355"/>
            <a:ext cx="622312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sv-SE" dirty="0"/>
          </a:p>
          <a:p>
            <a:r>
              <a:rPr lang="en-GB" b="1" i="0" u="none" strike="noStrike" dirty="0">
                <a:effectLst/>
              </a:rPr>
              <a:t>Supplementary Fig. 3A-C. </a:t>
            </a:r>
            <a:r>
              <a:rPr lang="en-GB" b="0" i="0" u="none" strike="noStrike" dirty="0">
                <a:effectLst/>
                <a:latin typeface="-webkit-standard"/>
              </a:rPr>
              <a:t>Frequency distribution of reported </a:t>
            </a:r>
            <a:r>
              <a:rPr lang="en-GB" b="0" i="0" u="none" strike="noStrike" dirty="0" err="1">
                <a:effectLst/>
                <a:latin typeface="-webkit-standard"/>
              </a:rPr>
              <a:t>PaPF</a:t>
            </a:r>
            <a:r>
              <a:rPr lang="en-GB" b="0" i="0" u="none" strike="noStrike" dirty="0">
                <a:effectLst/>
                <a:latin typeface="-webkit-standard"/>
              </a:rPr>
              <a:t> on the left leg under three conditions: dry electrode (A), after </a:t>
            </a:r>
            <a:r>
              <a:rPr lang="en-GB" b="0" i="0" u="none" strike="noStrike" dirty="0" err="1">
                <a:effectLst/>
                <a:latin typeface="-webkit-standard"/>
              </a:rPr>
              <a:t>gelpad</a:t>
            </a:r>
            <a:r>
              <a:rPr lang="en-GB" b="0" i="0" u="none" strike="noStrike" dirty="0">
                <a:effectLst/>
                <a:latin typeface="-webkit-standard"/>
              </a:rPr>
              <a:t> application (B), and after exfoliation with </a:t>
            </a:r>
            <a:r>
              <a:rPr lang="en-GB" b="0" i="0" u="none" strike="noStrike" dirty="0" err="1">
                <a:effectLst/>
                <a:latin typeface="-webkit-standard"/>
              </a:rPr>
              <a:t>gelpad</a:t>
            </a:r>
            <a:r>
              <a:rPr lang="en-GB" b="0" i="0" u="none" strike="noStrike" dirty="0">
                <a:effectLst/>
                <a:latin typeface="-webkit-standard"/>
              </a:rPr>
              <a:t> application (C), highlighting changes across interventions.</a:t>
            </a:r>
            <a:endParaRPr lang="sv-SE" dirty="0"/>
          </a:p>
          <a:p>
            <a:endParaRPr lang="sv-SE" dirty="0"/>
          </a:p>
        </p:txBody>
      </p:sp>
      <p:pic>
        <p:nvPicPr>
          <p:cNvPr id="9" name="Content Placeholder 4" descr="A graph of a number of pain rating scale&#10;&#10;AI-generated content may be incorrect.">
            <a:extLst>
              <a:ext uri="{FF2B5EF4-FFF2-40B4-BE49-F238E27FC236}">
                <a16:creationId xmlns:a16="http://schemas.microsoft.com/office/drawing/2014/main" id="{34B24D22-5283-DE74-406A-49E706B931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4262" y="2578192"/>
            <a:ext cx="4086841" cy="2802406"/>
          </a:xfrm>
          <a:prstGeom prst="rect">
            <a:avLst/>
          </a:prstGeom>
        </p:spPr>
      </p:pic>
      <p:pic>
        <p:nvPicPr>
          <p:cNvPr id="10" name="Content Placeholder 4" descr="A graph of a number of pain rating scale&#10;&#10;AI-generated content may be incorrect.">
            <a:extLst>
              <a:ext uri="{FF2B5EF4-FFF2-40B4-BE49-F238E27FC236}">
                <a16:creationId xmlns:a16="http://schemas.microsoft.com/office/drawing/2014/main" id="{98DB0336-2C1F-A411-C10A-CB041025C63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2579" y="2578192"/>
            <a:ext cx="4086841" cy="2802406"/>
          </a:xfrm>
          <a:prstGeom prst="rect">
            <a:avLst/>
          </a:prstGeom>
        </p:spPr>
      </p:pic>
      <p:pic>
        <p:nvPicPr>
          <p:cNvPr id="11" name="Content Placeholder 4" descr="A graph of a number of pain rating scale&#10;&#10;AI-generated content may be incorrect.">
            <a:extLst>
              <a:ext uri="{FF2B5EF4-FFF2-40B4-BE49-F238E27FC236}">
                <a16:creationId xmlns:a16="http://schemas.microsoft.com/office/drawing/2014/main" id="{3CD30351-8A84-A4E6-F638-07BF89B37C0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0898" y="2578192"/>
            <a:ext cx="4086841" cy="2802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52803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21EE4E-3204-2171-B357-A4C3FBE76D4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73DDB93-001A-CE9D-69E3-01E951C1F1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4526061"/>
              </p:ext>
            </p:extLst>
          </p:nvPr>
        </p:nvGraphicFramePr>
        <p:xfrm>
          <a:off x="247394" y="461665"/>
          <a:ext cx="7560000" cy="6224397"/>
        </p:xfrm>
        <a:graphic>
          <a:graphicData uri="http://schemas.openxmlformats.org/drawingml/2006/table">
            <a:tbl>
              <a:tblPr firstRow="1" firstCol="1" bandRow="1"/>
              <a:tblGrid>
                <a:gridCol w="1615246">
                  <a:extLst>
                    <a:ext uri="{9D8B030D-6E8A-4147-A177-3AD203B41FA5}">
                      <a16:colId xmlns:a16="http://schemas.microsoft.com/office/drawing/2014/main" val="1759567562"/>
                    </a:ext>
                  </a:extLst>
                </a:gridCol>
                <a:gridCol w="717377">
                  <a:extLst>
                    <a:ext uri="{9D8B030D-6E8A-4147-A177-3AD203B41FA5}">
                      <a16:colId xmlns:a16="http://schemas.microsoft.com/office/drawing/2014/main" val="66561672"/>
                    </a:ext>
                  </a:extLst>
                </a:gridCol>
                <a:gridCol w="765561">
                  <a:extLst>
                    <a:ext uri="{9D8B030D-6E8A-4147-A177-3AD203B41FA5}">
                      <a16:colId xmlns:a16="http://schemas.microsoft.com/office/drawing/2014/main" val="2191008779"/>
                    </a:ext>
                  </a:extLst>
                </a:gridCol>
                <a:gridCol w="1270325">
                  <a:extLst>
                    <a:ext uri="{9D8B030D-6E8A-4147-A177-3AD203B41FA5}">
                      <a16:colId xmlns:a16="http://schemas.microsoft.com/office/drawing/2014/main" val="3732379091"/>
                    </a:ext>
                  </a:extLst>
                </a:gridCol>
                <a:gridCol w="926167">
                  <a:extLst>
                    <a:ext uri="{9D8B030D-6E8A-4147-A177-3AD203B41FA5}">
                      <a16:colId xmlns:a16="http://schemas.microsoft.com/office/drawing/2014/main" val="3329512165"/>
                    </a:ext>
                  </a:extLst>
                </a:gridCol>
                <a:gridCol w="1307035">
                  <a:extLst>
                    <a:ext uri="{9D8B030D-6E8A-4147-A177-3AD203B41FA5}">
                      <a16:colId xmlns:a16="http://schemas.microsoft.com/office/drawing/2014/main" val="3187031815"/>
                    </a:ext>
                  </a:extLst>
                </a:gridCol>
                <a:gridCol w="958289">
                  <a:extLst>
                    <a:ext uri="{9D8B030D-6E8A-4147-A177-3AD203B41FA5}">
                      <a16:colId xmlns:a16="http://schemas.microsoft.com/office/drawing/2014/main" val="963453802"/>
                    </a:ext>
                  </a:extLst>
                </a:gridCol>
              </a:tblGrid>
              <a:tr h="56703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/ </a:t>
                      </a:r>
                      <a:b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edictors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² /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j. R²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 (SE)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β (Coefficient)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5% CI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edictor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9954577"/>
                  </a:ext>
                </a:extLst>
              </a:tr>
              <a:tr h="56703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edance (</a:t>
                      </a:r>
                      <a:r>
                        <a:rPr lang="en-US" sz="1100" b="1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Ohm</a:t>
                      </a:r>
                      <a:r>
                        <a:rPr lang="en-US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foliation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32 / 0.195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1*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9696548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der</a:t>
                      </a:r>
                      <a:r>
                        <a:rPr lang="sv-SE" sz="1100" kern="0" baseline="300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298 (1.011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95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1.75, 2.34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770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5134049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marL="457200" indent="-45720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e (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ears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42 (0.022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323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00, 0.09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63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8457260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marL="457200" indent="-45720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eight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Kg)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64 (0.052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575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17, 0.04]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227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5903860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marL="457200" indent="-45720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ody 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ss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Index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304 (0.205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602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11, 0.72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146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3345452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marL="457200" indent="-45720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S 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avy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Body Fat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60 (0.048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334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16, 0.04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218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9469973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hysical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ivity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412 (0.177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359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77, -0.05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26*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5085755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arting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Leg</a:t>
                      </a:r>
                      <a:r>
                        <a:rPr lang="sv-SE" sz="1100" kern="0" baseline="300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b</a:t>
                      </a:r>
                      <a:endParaRPr lang="sv-SE" sz="1300" kern="100" baseline="300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69 (0.443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22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97, 0.83]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878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2765181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plied NMES Current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137 (0.079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255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30, 0.02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90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1027782"/>
                  </a:ext>
                </a:extLst>
              </a:tr>
              <a:tr h="56703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b="1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edance (kOhm) 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l Pad after Exfoliation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86 / 0.260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9**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7474525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der </a:t>
                      </a:r>
                      <a:r>
                        <a:rPr lang="sv-SE" sz="1100" kern="0" baseline="300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sv-SE" sz="1300" kern="100" baseline="300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054 (0.645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496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1.89, 3.90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111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6935002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41 (0.014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471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00, 0.12]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06**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6563435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eight (Kg)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24 (0.034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316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22, 0.09]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483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5035032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ody 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ss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Index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222 (0.134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645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16, 1.03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107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5738808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S 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avy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Body Fat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73 (0.031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598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27, 0.00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25*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580580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hysical Activity Level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280 (0.115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359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1.09, -0.08]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20*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3674427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arting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Leg</a:t>
                      </a:r>
                      <a:r>
                        <a:rPr lang="sv-SE" sz="1100" kern="0" baseline="300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b</a:t>
                      </a:r>
                      <a:endParaRPr lang="sv-SE" sz="1300" kern="100" baseline="300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61 (0.282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29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2.82, -0.26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831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4267422"/>
                  </a:ext>
                </a:extLst>
              </a:tr>
              <a:tr h="266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plied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NMES 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urrent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3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37 (0.051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97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58, -0.17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475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420" marR="9420" marT="9420" marB="94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3112920"/>
                  </a:ext>
                </a:extLst>
              </a:tr>
              <a:tr h="266076">
                <a:tc gridSpan="7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100" baseline="300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Calibri" panose="020F0502020204030204" pitchFamily="34" charset="0"/>
                        </a:rPr>
                        <a:t>a </a:t>
                      </a:r>
                      <a:r>
                        <a:rPr lang="en-US" sz="11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Calibri" panose="020F0502020204030204" pitchFamily="34" charset="0"/>
                        </a:rPr>
                        <a:t>1 = Male, 2 = Female. </a:t>
                      </a:r>
                      <a:r>
                        <a:rPr lang="en-US" sz="1100" kern="100" baseline="300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Calibri" panose="020F0502020204030204" pitchFamily="34" charset="0"/>
                        </a:rPr>
                        <a:t>b</a:t>
                      </a:r>
                      <a:r>
                        <a:rPr lang="en-US" sz="11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Calibri" panose="020F0502020204030204" pitchFamily="34" charset="0"/>
                        </a:rPr>
                        <a:t> 0 = Right, 1 = Left. * P &lt; 0.05, ** P &lt; 0.001.</a:t>
                      </a:r>
                      <a:endParaRPr lang="sv-SE" sz="1100" kern="100" dirty="0">
                        <a:effectLst/>
                        <a:latin typeface="Calibri" panose="020F0502020204030204" pitchFamily="34" charset="0"/>
                        <a:ea typeface="Aptos" panose="020B0004020202020204" pitchFamily="34" charset="0"/>
                        <a:cs typeface="Calibri" panose="020F0502020204030204" pitchFamily="34" charset="0"/>
                      </a:endParaRPr>
                    </a:p>
                  </a:txBody>
                  <a:tcPr marL="8893" marR="8893" marT="8893" marB="8893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19" marR="9219" marT="9219" marB="921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19" marR="9219" marT="9219" marB="921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19" marR="9219" marT="9219" marB="921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19" marR="9219" marT="9219" marB="921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19" marR="9219" marT="9219" marB="921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19" marR="9219" marT="9219" marB="921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3181475"/>
                  </a:ext>
                </a:extLst>
              </a:tr>
            </a:tbl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7FA01DC7-152F-B78F-57F9-CC92C5020D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393" y="0"/>
            <a:ext cx="7559999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Supplementary Table 1. </a:t>
            </a:r>
            <a:r>
              <a:rPr kumimoji="0" lang="en-US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Multiple linear regression analyses with stepwise regression of impedance at plantar flexion across different interventions on the right leg (n=49)</a:t>
            </a:r>
            <a:endParaRPr kumimoji="0" lang="sv-SE" altLang="sv-S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81545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C2EE654-5B19-A580-B527-70366326C6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4705986"/>
              </p:ext>
            </p:extLst>
          </p:nvPr>
        </p:nvGraphicFramePr>
        <p:xfrm>
          <a:off x="331860" y="461665"/>
          <a:ext cx="7560000" cy="6235640"/>
        </p:xfrm>
        <a:graphic>
          <a:graphicData uri="http://schemas.openxmlformats.org/drawingml/2006/table">
            <a:tbl>
              <a:tblPr firstRow="1" firstCol="1" bandRow="1"/>
              <a:tblGrid>
                <a:gridCol w="1615248">
                  <a:extLst>
                    <a:ext uri="{9D8B030D-6E8A-4147-A177-3AD203B41FA5}">
                      <a16:colId xmlns:a16="http://schemas.microsoft.com/office/drawing/2014/main" val="2157814700"/>
                    </a:ext>
                  </a:extLst>
                </a:gridCol>
                <a:gridCol w="717376">
                  <a:extLst>
                    <a:ext uri="{9D8B030D-6E8A-4147-A177-3AD203B41FA5}">
                      <a16:colId xmlns:a16="http://schemas.microsoft.com/office/drawing/2014/main" val="1404953737"/>
                    </a:ext>
                  </a:extLst>
                </a:gridCol>
                <a:gridCol w="765562">
                  <a:extLst>
                    <a:ext uri="{9D8B030D-6E8A-4147-A177-3AD203B41FA5}">
                      <a16:colId xmlns:a16="http://schemas.microsoft.com/office/drawing/2014/main" val="3288399316"/>
                    </a:ext>
                  </a:extLst>
                </a:gridCol>
                <a:gridCol w="1270325">
                  <a:extLst>
                    <a:ext uri="{9D8B030D-6E8A-4147-A177-3AD203B41FA5}">
                      <a16:colId xmlns:a16="http://schemas.microsoft.com/office/drawing/2014/main" val="4011652290"/>
                    </a:ext>
                  </a:extLst>
                </a:gridCol>
                <a:gridCol w="926167">
                  <a:extLst>
                    <a:ext uri="{9D8B030D-6E8A-4147-A177-3AD203B41FA5}">
                      <a16:colId xmlns:a16="http://schemas.microsoft.com/office/drawing/2014/main" val="2491760643"/>
                    </a:ext>
                  </a:extLst>
                </a:gridCol>
                <a:gridCol w="1307034">
                  <a:extLst>
                    <a:ext uri="{9D8B030D-6E8A-4147-A177-3AD203B41FA5}">
                      <a16:colId xmlns:a16="http://schemas.microsoft.com/office/drawing/2014/main" val="4224105117"/>
                    </a:ext>
                  </a:extLst>
                </a:gridCol>
                <a:gridCol w="958288">
                  <a:extLst>
                    <a:ext uri="{9D8B030D-6E8A-4147-A177-3AD203B41FA5}">
                      <a16:colId xmlns:a16="http://schemas.microsoft.com/office/drawing/2014/main" val="3712429490"/>
                    </a:ext>
                  </a:extLst>
                </a:gridCol>
              </a:tblGrid>
              <a:tr h="54602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/ </a:t>
                      </a:r>
                      <a:b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edictors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² /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j. R²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sv-SE" sz="1100" b="1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 (SE)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β (</a:t>
                      </a:r>
                      <a:r>
                        <a:rPr lang="sv-SE" sz="1100" b="1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efficient</a:t>
                      </a:r>
                      <a: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5% CI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edictor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sv-SE" sz="1100" b="1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1002411"/>
                  </a:ext>
                </a:extLst>
              </a:tr>
              <a:tr h="5460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edance (</a:t>
                      </a:r>
                      <a:r>
                        <a:rPr lang="en-US" sz="1100" b="1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Ohm</a:t>
                      </a:r>
                      <a:r>
                        <a:rPr lang="en-US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l Pad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92 / 0.388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**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0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0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0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0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5629028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der </a:t>
                      </a:r>
                      <a:r>
                        <a:rPr lang="sv-SE" sz="1100" kern="0" baseline="300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sv-SE" sz="1100" kern="100" baseline="300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443 (0.562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703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0.31, 2.58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14*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6300848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marL="457200" indent="-45720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e (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ears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43 (0.012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505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0.02, 0.07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01**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6836798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marL="457200" indent="-45720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eight (Kg)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11 (0.030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152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07, 0.05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711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1149646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marL="457200" indent="-45720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ody Mass Index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213 (0.119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642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03, 0.45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80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712163"/>
                  </a:ext>
                </a:extLst>
              </a:tr>
              <a:tr h="266400">
                <a:tc>
                  <a:txBody>
                    <a:bodyPr/>
                    <a:lstStyle/>
                    <a:p>
                      <a:pPr marL="457200" indent="-45720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S Navy Body Fat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94 (0.028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795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15, -0.04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02**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4628064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hysical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ivity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302 (0.101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401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51, -0.10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05**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2304731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arting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Leg </a:t>
                      </a:r>
                      <a:r>
                        <a:rPr lang="sv-SE" sz="1100" kern="0" baseline="300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sv-SE" sz="1100" kern="100" baseline="300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215 (0.252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105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72, 0.30]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399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9933709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plied NMES Current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89 (0.040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271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17, -0.01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33*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2303320"/>
                  </a:ext>
                </a:extLst>
              </a:tr>
              <a:tr h="5460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edance (</a:t>
                      </a:r>
                      <a:r>
                        <a:rPr lang="en-US" sz="1100" b="1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Ohm</a:t>
                      </a:r>
                      <a:r>
                        <a:rPr lang="en-US" sz="1100" b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foliation after Gel Pad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96 / 0.390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**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6048310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der </a:t>
                      </a:r>
                      <a:r>
                        <a:rPr lang="sv-SE" sz="1100" kern="0" baseline="300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sv-SE" sz="1100" kern="100" baseline="300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550 (0.624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690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0.29, 2.81]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17*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8536452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43 (0.013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471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0.02, 0.07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03**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8894244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eight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Kg)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22 (0.033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273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09, 0.05]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515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7225599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ody 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ss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Index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237 (0.130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659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03, 0.50]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75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9385967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S Navy Body Fat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86 (0.030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655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15, -0.03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07**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5830884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hysical Activity Level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253 (0.112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305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48, -0.03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29*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1700278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arting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Leg </a:t>
                      </a:r>
                      <a:r>
                        <a:rPr lang="sv-SE" sz="1100" kern="0" baseline="300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sv-SE" sz="1100" kern="100" baseline="300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106 (0.273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048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66, 0.45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700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5853200"/>
                  </a:ext>
                </a:extLst>
              </a:tr>
              <a:tr h="25621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plied</a:t>
                      </a: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NMES </a:t>
                      </a:r>
                      <a:r>
                        <a:rPr lang="sv-SE" sz="1100" kern="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urrent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10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sv-SE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126 (0.044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-0.350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[-0.22, -0.04]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sv-SE" sz="12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007**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00" marR="9200" marT="9200" marB="9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9911000"/>
                  </a:ext>
                </a:extLst>
              </a:tr>
              <a:tr h="486846">
                <a:tc gridSpan="7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00" baseline="300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Calibri" panose="020F0502020204030204" pitchFamily="34" charset="0"/>
                        </a:rPr>
                        <a:t>a </a:t>
                      </a:r>
                      <a:r>
                        <a:rPr lang="en-US" sz="11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Calibri" panose="020F0502020204030204" pitchFamily="34" charset="0"/>
                        </a:rPr>
                        <a:t>1 = Male, 2 = Female. </a:t>
                      </a:r>
                      <a:r>
                        <a:rPr lang="en-US" sz="1100" kern="100" baseline="300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Calibri" panose="020F0502020204030204" pitchFamily="34" charset="0"/>
                        </a:rPr>
                        <a:t>b</a:t>
                      </a:r>
                      <a:r>
                        <a:rPr lang="en-US" sz="1100" kern="100" dirty="0"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Calibri" panose="020F0502020204030204" pitchFamily="34" charset="0"/>
                        </a:rPr>
                        <a:t> 0 = Right, 1 = Left. * P &lt; 0.05, ** P &lt; 0.001.</a:t>
                      </a:r>
                      <a:endParaRPr lang="sv-SE" sz="1100" kern="100" dirty="0">
                        <a:effectLst/>
                        <a:latin typeface="Calibri" panose="020F0502020204030204" pitchFamily="34" charset="0"/>
                        <a:ea typeface="Aptos" panose="020B0004020202020204" pitchFamily="34" charset="0"/>
                        <a:cs typeface="Calibri" panose="020F050202020403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05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256" marR="9256" marT="9256" marB="9256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00" marR="9100" marT="9100" marB="91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00" marR="9100" marT="9100" marB="91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00" marR="9100" marT="9100" marB="910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00" marR="9100" marT="9100" marB="910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00" marR="9100" marT="9100" marB="910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100" marR="9100" marT="9100" marB="910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0736999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7A724891-D661-4206-F990-9575036289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859" y="0"/>
            <a:ext cx="7476567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Supplementary Table 2. </a:t>
            </a:r>
            <a:r>
              <a:rPr kumimoji="0" lang="en-US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Multiple linear regression analyses with stepwise regression of impedance at plantar flexion across different interventions on the left leg (n=49).</a:t>
            </a:r>
            <a:endParaRPr kumimoji="0" lang="en-US" altLang="sv-S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41959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7</TotalTime>
  <Words>920</Words>
  <Application>Microsoft Office PowerPoint</Application>
  <PresentationFormat>Widescreen</PresentationFormat>
  <Paragraphs>27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-webkit-standar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mpedance Study</dc:title>
  <dc:creator>Philip Wackendal</dc:creator>
  <cp:lastModifiedBy>Philip Wackendal</cp:lastModifiedBy>
  <cp:revision>7</cp:revision>
  <dcterms:created xsi:type="dcterms:W3CDTF">2025-08-08T10:40:42Z</dcterms:created>
  <dcterms:modified xsi:type="dcterms:W3CDTF">2026-02-24T21:47:04Z</dcterms:modified>
</cp:coreProperties>
</file>